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AA37E-790D-8843-36DB-62418BFDFF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F6168F-9452-DA16-CE36-8E1B9E9544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8FF04-D238-9840-7E4B-2E8235288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C815A1-3CE2-F6B8-8AB4-C57A58E92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5A79F3-A5CC-9E19-359F-98AFEDC98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90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BD485-D9D2-E4DE-3F75-ECC8C54F68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0B5712-4F8C-AEFD-87C0-C1228D591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140D15-4FA4-5942-1CBA-89DD06526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2E997-F77F-2861-5469-D8BC85AE4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DFC0F-8BF2-591F-12A3-3303DD8E9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628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4902E5-2BF6-CD5F-6646-79B3A20C96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6BD694-8D39-D7C9-5299-0C711469C2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96B8A-D774-186B-6436-4527CBB5A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CC0E4-7418-497A-100E-2CE4556A6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2137E-D470-F28B-0760-E54A26BE1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658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CD614-E0DF-B1E9-AF11-C0DDD41B5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65F92E-0F02-D8CF-BE56-346348C2ED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EECCE-FD4D-707F-C809-35233D1C9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D0E795-17C9-03F1-5B60-142A70A36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FF9D80-3913-D1B1-C8F7-014D61A62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04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F7025-B88F-D98D-CB8C-C35C43469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0065D0-7EE8-5865-6482-5311E71DDB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25345-EB89-8838-9D45-65A659987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4C434B-188D-982D-C38B-A7D192ABA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51445E-7D9F-1FA6-D345-8B662A697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002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9275D9-6652-6651-ED94-18EA675ED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81807-95C6-E5CE-BCA7-CEFB310DD1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A2CF87-41D1-0DEA-D184-12888950F2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49F2C-FBDA-2068-EA4A-E8F8D2820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2AFF18-928C-BD33-8AE1-DF241BD46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5879E2-8167-A98B-AF8E-A45066C02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016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847F2-A6B8-D70C-EFFE-BCB6F38DD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E3AF31-6046-9395-D839-391D1B13C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01A638-C176-FA2E-D73F-DE04475CA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B543B9-972E-641B-CF6D-B85FD2BE89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81BECD-55A9-65A3-2593-18C517659C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A3DD07E-A9AA-30D6-8562-3AB3D0FB7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6D9FF0-827D-5361-467A-88D44BFA7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339704-CE7D-CF9F-9113-8E3A5DEB4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501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E6438-C1B8-7FAD-629D-EF7F6C199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0DA572-A775-2B44-4A31-0969FA501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DC2ABD-F754-A99E-9EF7-D4809740B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AFB7F1-74E0-E630-2E25-8A88EFDCA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468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11028D-37E2-08D6-3F12-219F7DF8D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0825C7-9E2C-4A48-15E7-FA2312083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5B4A41-86C6-90AE-6CAB-078233641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712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2981-22FC-93A8-0911-28528F977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E37C3E-0128-CEAE-4A67-0B347847C0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C85C4A-6D05-7085-D937-08CEC16958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6B007D-57DE-0C59-F914-8F8CC826D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88C558-2E08-BF24-B076-26CB50767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4E9812-97C8-0B46-310E-B436E83B2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7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EC134-1BB5-1A9C-FE96-82E4DDBF61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517CE3-A52E-D533-00CF-6656323FFC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970D7B-0B1E-48D6-8FD6-DE29AC759D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DDF9B4-2E6F-07DC-E84D-9E85A36E3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9FAF3D-B67F-A2EE-DEB4-F36F4DEF8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2AEF5E-A635-ACCD-E0DB-AEFA284BA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427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E1A5AD-59CE-CA75-8011-58E4ADA46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024F85-87B2-4171-9589-BECF8AA92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2F145B-E802-D98E-ADD3-3616E7FB826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CF50068-97C4-4FC8-A9D2-5E067F19AAD0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0A2A2A-0F32-685A-1356-E2CAB2464B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C74E0-63D5-CCAE-F62B-4298005A98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D1114C-37E9-4D39-B88B-C756E8589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92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1E6416F-49FB-5D37-CE1E-0EBFCCC63DA2}"/>
              </a:ext>
            </a:extLst>
          </p:cNvPr>
          <p:cNvSpPr txBox="1"/>
          <p:nvPr/>
        </p:nvSpPr>
        <p:spPr>
          <a:xfrm>
            <a:off x="103695" y="104646"/>
            <a:ext cx="11660957" cy="687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>
              <a:spcAft>
                <a:spcPts val="800"/>
              </a:spcAft>
            </a:pP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MXene/</a:t>
            </a:r>
            <a:r>
              <a:rPr lang="en-US" altLang="ko-KR" sz="1600" b="1" kern="100" dirty="0" err="1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nO</a:t>
            </a: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anorods: WO₃/CNT </a:t>
            </a:r>
            <a:r>
              <a:rPr lang="en-US" altLang="ko-KR" sz="1600" b="1" kern="100" dirty="0" err="1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ilayer</a:t>
            </a: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atings on </a:t>
            </a:r>
          </a:p>
          <a:p>
            <a:pPr algn="ctr" latinLnBrk="1">
              <a:spcAft>
                <a:spcPts val="800"/>
              </a:spcAft>
            </a:pP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tton for High-Performance Multifunctional Wearable Fabrics</a:t>
            </a:r>
            <a:endParaRPr lang="en-US" altLang="ko-KR" sz="1400" kern="100" dirty="0">
              <a:solidFill>
                <a:schemeClr val="tx2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BBD5D5-2D5C-4982-3935-99EED1FFF0FD}"/>
              </a:ext>
            </a:extLst>
          </p:cNvPr>
          <p:cNvSpPr txBox="1"/>
          <p:nvPr/>
        </p:nvSpPr>
        <p:spPr>
          <a:xfrm>
            <a:off x="103695" y="1905225"/>
            <a:ext cx="87645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latinLnBrk="1">
              <a:spcBef>
                <a:spcPts val="0"/>
              </a:spcBef>
              <a:spcAft>
                <a:spcPts val="800"/>
              </a:spcAft>
            </a:pPr>
            <a:r>
              <a:rPr lang="en-US" sz="1400" b="1" kern="1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Video S1: </a:t>
            </a:r>
            <a:r>
              <a:rPr lang="en-US" sz="1400" kern="1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earable strain sensing performance</a:t>
            </a:r>
            <a:endParaRPr lang="en-US" sz="1200" kern="100" dirty="0">
              <a:effectLst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2" name="Video">
            <a:hlinkClick r:id="" action="ppaction://media"/>
            <a:extLst>
              <a:ext uri="{FF2B5EF4-FFF2-40B4-BE49-F238E27FC236}">
                <a16:creationId xmlns:a16="http://schemas.microsoft.com/office/drawing/2014/main" id="{E5D27E53-B637-3271-7311-ADE01BB17D9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79388" y="1981515"/>
            <a:ext cx="2941163" cy="420191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0011B6E-7AD8-4EF1-0905-17B4D8F2866A}"/>
              </a:ext>
            </a:extLst>
          </p:cNvPr>
          <p:cNvSpPr txBox="1"/>
          <p:nvPr/>
        </p:nvSpPr>
        <p:spPr>
          <a:xfrm>
            <a:off x="2157560" y="881174"/>
            <a:ext cx="75532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rumalaisamy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yaprabha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hyeon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i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jith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l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Ergang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ng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ungil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wang</a:t>
            </a:r>
            <a:r>
              <a:rPr lang="en-GB" altLang="ko-KR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*</a:t>
            </a:r>
            <a:endParaRPr lang="ko-KR" altLang="en-US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그림 2" descr="관련 이미지">
            <a:extLst>
              <a:ext uri="{FF2B5EF4-FFF2-40B4-BE49-F238E27FC236}">
                <a16:creationId xmlns:a16="http://schemas.microsoft.com/office/drawing/2014/main" id="{F38A16FB-5721-1B81-4D99-D428DB2A6E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4215" y="234962"/>
            <a:ext cx="960437" cy="800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A409881-AC41-0D7E-5E6A-BA62A17A2CE1}"/>
              </a:ext>
            </a:extLst>
          </p:cNvPr>
          <p:cNvCxnSpPr/>
          <p:nvPr/>
        </p:nvCxnSpPr>
        <p:spPr>
          <a:xfrm>
            <a:off x="0" y="1508288"/>
            <a:ext cx="12192000" cy="0"/>
          </a:xfrm>
          <a:prstGeom prst="line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56548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6633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41E6416F-49FB-5D37-CE1E-0EBFCCC63DA2}"/>
              </a:ext>
            </a:extLst>
          </p:cNvPr>
          <p:cNvSpPr txBox="1"/>
          <p:nvPr/>
        </p:nvSpPr>
        <p:spPr>
          <a:xfrm>
            <a:off x="103695" y="104646"/>
            <a:ext cx="11660957" cy="687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>
              <a:spcAft>
                <a:spcPts val="800"/>
              </a:spcAft>
            </a:pP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erarchical MXene/</a:t>
            </a:r>
            <a:r>
              <a:rPr lang="en-US" altLang="ko-KR" sz="1600" b="1" kern="100" dirty="0" err="1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nO</a:t>
            </a: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anorods: WO₃/CNT </a:t>
            </a:r>
            <a:r>
              <a:rPr lang="en-US" altLang="ko-KR" sz="1600" b="1" kern="100" dirty="0" err="1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ilayer</a:t>
            </a: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atings on </a:t>
            </a:r>
          </a:p>
          <a:p>
            <a:pPr algn="ctr" latinLnBrk="1">
              <a:spcAft>
                <a:spcPts val="800"/>
              </a:spcAft>
            </a:pPr>
            <a:r>
              <a:rPr lang="en-US" altLang="ko-KR" sz="1600" b="1" kern="100" dirty="0">
                <a:solidFill>
                  <a:schemeClr val="tx2">
                    <a:lumMod val="75000"/>
                    <a:lumOff val="2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tton for High-Performance Multifunctional Wearable Fabrics</a:t>
            </a:r>
            <a:endParaRPr lang="en-US" altLang="ko-KR" sz="1400" kern="100" dirty="0">
              <a:solidFill>
                <a:schemeClr val="tx2">
                  <a:lumMod val="75000"/>
                  <a:lumOff val="2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BBBD5D5-2D5C-4982-3935-99EED1FFF0FD}"/>
              </a:ext>
            </a:extLst>
          </p:cNvPr>
          <p:cNvSpPr txBox="1"/>
          <p:nvPr/>
        </p:nvSpPr>
        <p:spPr>
          <a:xfrm>
            <a:off x="103695" y="1905225"/>
            <a:ext cx="87645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400" b="1" kern="100" dirty="0">
                <a:latin typeface="Arial" panose="020B0604020202020204" pitchFamily="34" charset="0"/>
                <a:cs typeface="Arial" panose="020B0604020202020204" pitchFamily="34" charset="0"/>
              </a:rPr>
              <a:t>Video S2: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Alert warning system for safety line crossing</a:t>
            </a:r>
            <a:endParaRPr lang="en-US" altLang="ko-KR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011B6E-7AD8-4EF1-0905-17B4D8F2866A}"/>
              </a:ext>
            </a:extLst>
          </p:cNvPr>
          <p:cNvSpPr txBox="1"/>
          <p:nvPr/>
        </p:nvSpPr>
        <p:spPr>
          <a:xfrm>
            <a:off x="2157560" y="881174"/>
            <a:ext cx="75532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rumalaisamy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yaprabha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hyeon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oi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jith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l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Ergang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ng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ungil</a:t>
            </a:r>
            <a:r>
              <a:rPr lang="en-GB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wang</a:t>
            </a:r>
            <a:r>
              <a:rPr lang="en-GB" altLang="ko-KR" sz="14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altLang="ko-KR" sz="14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그림 2" descr="관련 이미지">
            <a:extLst>
              <a:ext uri="{FF2B5EF4-FFF2-40B4-BE49-F238E27FC236}">
                <a16:creationId xmlns:a16="http://schemas.microsoft.com/office/drawing/2014/main" id="{F38A16FB-5721-1B81-4D99-D428DB2A6E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4215" y="234962"/>
            <a:ext cx="960437" cy="800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A409881-AC41-0D7E-5E6A-BA62A17A2CE1}"/>
              </a:ext>
            </a:extLst>
          </p:cNvPr>
          <p:cNvCxnSpPr/>
          <p:nvPr/>
        </p:nvCxnSpPr>
        <p:spPr>
          <a:xfrm>
            <a:off x="0" y="1508288"/>
            <a:ext cx="12192000" cy="0"/>
          </a:xfrm>
          <a:prstGeom prst="line">
            <a:avLst/>
          </a:prstGeom>
          <a:ln w="38100">
            <a:solidFill>
              <a:schemeClr val="tx2">
                <a:lumMod val="75000"/>
                <a:lumOff val="25000"/>
              </a:schemeClr>
            </a:solidFill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pic>
        <p:nvPicPr>
          <p:cNvPr id="3" name="20250527_115653_1 (1) (online-video-cutter.com)">
            <a:hlinkClick r:id="" action="ppaction://media"/>
            <a:extLst>
              <a:ext uri="{FF2B5EF4-FFF2-40B4-BE49-F238E27FC236}">
                <a16:creationId xmlns:a16="http://schemas.microsoft.com/office/drawing/2014/main" id="{F99CF739-6A1A-9CA9-750D-98B3A81EC41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890155" y="1827626"/>
            <a:ext cx="3978111" cy="4686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11948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98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100000">
                <p:cTn id="12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5</Words>
  <Application>Microsoft Office PowerPoint</Application>
  <PresentationFormat>Widescreen</PresentationFormat>
  <Paragraphs>8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수리아프라바</dc:creator>
  <cp:lastModifiedBy>수리아프라바</cp:lastModifiedBy>
  <cp:revision>5</cp:revision>
  <dcterms:created xsi:type="dcterms:W3CDTF">2025-06-02T16:33:47Z</dcterms:created>
  <dcterms:modified xsi:type="dcterms:W3CDTF">2025-07-28T09:49:46Z</dcterms:modified>
</cp:coreProperties>
</file>